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CA905C6-4620-A44E-887A-71A05879C699}" v="3" dt="2025-08-23T22:56:05.191"/>
    <p1510:client id="{9A32103D-4C2B-8B4B-9BB2-25892859F7C0}" v="1" dt="2025-08-24T01:11:16.6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057"/>
    <p:restoredTop sz="94655"/>
  </p:normalViewPr>
  <p:slideViewPr>
    <p:cSldViewPr snapToGrid="0">
      <p:cViewPr varScale="1">
        <p:scale>
          <a:sx n="85" d="100"/>
          <a:sy n="85" d="100"/>
        </p:scale>
        <p:origin x="184" y="8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8D3E2-48DE-671E-FFEA-01FF3C2169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9CE8D4-63B5-EA3F-02C5-50925C166F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790BD4-AC31-B4F3-E9E4-87C13AFAE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724099-FAA4-5009-7B79-D9EFE3BBA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6B12E0-5020-6E5D-BB2B-A7124BD963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889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CFA457-2B62-5FB0-7E57-2EDF1C3B0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373D9D-4A3F-594C-E8F0-6EF20E5E71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B071EA-B5BD-D539-812B-07F19FAFF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E2EE3F-17A4-37BB-C83E-CDC8A0DD3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CEDF0F-93D5-CA21-2AA0-44F9ADAE9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432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4D0B77-96EF-CB1F-7D11-C0A21FA2E2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3051B1-BE74-68A4-C39D-CC2356CCA7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A4B3B6-87A2-72DB-9098-0175DFDB2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0BE69B-B6ED-EB4E-3A8F-459203ED2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EA7CBC-2A1A-1716-D2D6-343CD0D10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703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6836F3-A165-D0F8-5599-93163B5E4E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F6C5D8-442C-D5E3-0EF9-0770ECDC38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4A645A-43F8-1631-0B7A-4E050905A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78B471-6777-5CC4-B47F-8CED044C4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E1B474-22A1-6053-F9E3-ED148C9CC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576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535DF5-C38A-26A2-641B-12B05EAF90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36D493-3D05-E1F2-D0F7-E787509C02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A914FF-E4AD-F93C-D9BE-2C25C180D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18098A-6E8A-7B57-07F3-6CA2E9873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8B36D0-6096-E56F-6246-6105BADBB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932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BC65F7-A1E1-3F0A-2B36-3E0924890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A4A79D-B584-4346-55F9-4CB2F0DFBF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8C4D6D-4E6A-2BEA-6CA4-4200CCF963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6F3427-84D9-6C55-EC25-128D2878F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C67307-2D2E-FA0A-A843-A944D7C45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B84773-0364-B693-995A-C61FE3CED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647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506270-B635-BFBF-2BF5-5610F4E32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2C9410-90F8-16B8-C3C1-0DFE3732D3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9855D7-1242-A9A1-B290-D92E346351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6635FD-EAE4-3079-C3DE-FEBC1D1117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B9C3A3-B54A-6DDC-2EFD-1B84E0A076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4789EE-6CA1-38FE-B362-A6A534E67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B592B5-5E04-17F6-6F9C-AA7E2E843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18F46B-6CC1-418D-A1FE-649970BAB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984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4C89B7-01E0-A997-ADFC-5B6C881A4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59C847-BB31-9ECE-31BB-61CC71571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D19140-4F2F-471B-1D4E-A9A44E6C6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14197B-D387-CE60-138F-7B566FC05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624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CAFF45-2C3D-D189-6E5A-7A7AE6E13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3254194-5652-B06E-FFD2-1CB73F32C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AD8AC8-0A0C-B3AE-9CBE-2C1CDE3E9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502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1119D-490C-BC8C-C832-B18FF4BEE5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3F6A8C-AC21-581B-ED3E-FA87DE6409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A0D96E-637F-F61E-E5CB-2B4A6D36A9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5F931D-BF89-A9B6-4E52-838FF5443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4A5848-2665-B149-D62F-FB0E66609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3C28AF-CC4B-B8F2-1D23-C97071E1B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645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DC27BA-C709-0549-9F85-D99679F789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39B816-D282-789D-FAD4-1078A5F5FE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146316-823D-3E4A-F5CE-71A9392810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8188F2-52A8-417A-32A3-07D294D49E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8CEF2A-D5F9-4063-1EC4-F8F569AE2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84EF04-DACC-1E24-A7F2-CF51075E1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447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29BE83-40F7-C899-5E9E-ECE1FDE7A8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129990-81CA-770F-0D58-F0C55C9717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09D9DE-8256-9C30-9BAE-A7721EC87F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2F0368-38AE-884A-B15A-3FA75554A9CD}" type="datetimeFigureOut">
              <a:rPr lang="en-US" smtClean="0"/>
              <a:t>8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B743F6-B694-EFA2-5076-02533CCFFF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F22D7C-8C95-2523-2361-809CA57AF6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FBC7BF-2074-8A48-8D13-D4882FE64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667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26309E23-05F7-F726-5107-AB5D8EFE7FF2}"/>
              </a:ext>
            </a:extLst>
          </p:cNvPr>
          <p:cNvSpPr txBox="1"/>
          <p:nvPr/>
        </p:nvSpPr>
        <p:spPr>
          <a:xfrm>
            <a:off x="7832070" y="1749478"/>
            <a:ext cx="4302778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I. Dangoisse Method.  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llustration demonstrating anatomical landmarks for a landmark-guided suprascapular nerve block. To identify the injection site, first draw a line along the spine of the scapula. Then, draw a second line perpendicular to the first, extending from the inferior angle of the scapula to bisect the spine. From the intersection, measure 2 cm laterally along the scapular spine and mark this point above the spine as the injection site (‘×’). After anaesthetising the skin with a 25G needle, insert a 21G needle at the marked site. Advance the needle, walking off the superior border of the scapular spine until contacting the bony floor of the supraspinous fossa. Aspirate before injecting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380FB7D-4ADC-0678-C3AE-7A0EBD90A2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660" y="295457"/>
            <a:ext cx="7772400" cy="5955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9024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</TotalTime>
  <Words>12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HOU, Andrew (UNIVERSITY HOSPITALS COVENTRY AND WARWICKSHIRE NHS TRUST)</dc:creator>
  <cp:lastModifiedBy>Dave Duru</cp:lastModifiedBy>
  <cp:revision>3</cp:revision>
  <dcterms:created xsi:type="dcterms:W3CDTF">2025-08-22T17:17:46Z</dcterms:created>
  <dcterms:modified xsi:type="dcterms:W3CDTF">2025-08-24T01:11:16Z</dcterms:modified>
</cp:coreProperties>
</file>